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0260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6332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2582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4816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357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4759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042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444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4559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703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0982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355695-7590-4F02-BF5F-D9616E1760DC}" type="datetimeFigureOut">
              <a:rPr lang="ko-KR" altLang="en-US" smtClean="0"/>
              <a:t>2018-09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DFB06-0A61-4EDB-AB6A-0B65542287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7654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직선 연결선 4"/>
          <p:cNvCxnSpPr/>
          <p:nvPr/>
        </p:nvCxnSpPr>
        <p:spPr>
          <a:xfrm flipH="1">
            <a:off x="2287125" y="1047805"/>
            <a:ext cx="3142" cy="89103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2287373" y="2104178"/>
            <a:ext cx="0" cy="103808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457332" y="1312099"/>
            <a:ext cx="7840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IP : Flag</a:t>
            </a:r>
            <a:endParaRPr lang="ko-KR" altLang="en-US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530231" y="2418859"/>
            <a:ext cx="729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Lysate</a:t>
            </a:r>
            <a:endParaRPr lang="ko-KR" altLang="en-US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426061" y="427510"/>
            <a:ext cx="373380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   WT        </a:t>
            </a:r>
            <a:r>
              <a:rPr lang="en-US" altLang="ko-KR" sz="1000" dirty="0" err="1" smtClean="0"/>
              <a:t>WT</a:t>
            </a:r>
            <a:r>
              <a:rPr lang="en-US" altLang="ko-KR" sz="1000" dirty="0" smtClean="0"/>
              <a:t>       S47A        S212A      S288A       S346A</a:t>
            </a:r>
            <a:endParaRPr lang="en-US" altLang="ko-KR" sz="1000" b="1" dirty="0" smtClean="0"/>
          </a:p>
          <a:p>
            <a:r>
              <a:rPr lang="en-US" altLang="ko-KR" sz="1000" b="1" dirty="0"/>
              <a:t> </a:t>
            </a:r>
            <a:r>
              <a:rPr lang="en-US" altLang="ko-KR" sz="1000" b="1" dirty="0" smtClean="0"/>
              <a:t>  </a:t>
            </a:r>
          </a:p>
          <a:p>
            <a:r>
              <a:rPr lang="en-US" altLang="ko-KR" sz="1000" b="1" dirty="0"/>
              <a:t> </a:t>
            </a:r>
            <a:r>
              <a:rPr lang="en-US" altLang="ko-KR" sz="1000" b="1" dirty="0" smtClean="0"/>
              <a:t>   -           +           +             +            +             +</a:t>
            </a:r>
            <a:endParaRPr lang="ko-KR" altLang="en-US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268568" y="427850"/>
            <a:ext cx="110678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/>
              <a:t> </a:t>
            </a:r>
            <a:r>
              <a:rPr lang="en-US" altLang="ko-KR" sz="1000" b="1" dirty="0" smtClean="0"/>
              <a:t>XBP1</a:t>
            </a:r>
          </a:p>
          <a:p>
            <a:endParaRPr lang="en-US" altLang="ko-KR" sz="1000" b="1" dirty="0"/>
          </a:p>
          <a:p>
            <a:pPr algn="ctr"/>
            <a:r>
              <a:rPr lang="en-US" altLang="ko-KR" sz="1000" b="1" dirty="0" smtClean="0"/>
              <a:t>Flag-Fbw7</a:t>
            </a:r>
            <a:endParaRPr lang="ko-KR" altLang="en-US" sz="1000" b="1" dirty="0"/>
          </a:p>
        </p:txBody>
      </p:sp>
      <p:cxnSp>
        <p:nvCxnSpPr>
          <p:cNvPr id="12" name="직선 연결선 11"/>
          <p:cNvCxnSpPr/>
          <p:nvPr/>
        </p:nvCxnSpPr>
        <p:spPr>
          <a:xfrm>
            <a:off x="2708786" y="327725"/>
            <a:ext cx="316835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482419" y="57062"/>
            <a:ext cx="15811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/>
              <a:t>Co-IP</a:t>
            </a:r>
            <a:endParaRPr lang="ko-KR" altLang="en-US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80479" y="1085248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XBP1</a:t>
            </a:r>
            <a:endParaRPr lang="ko-KR" altLang="en-US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6180479" y="1639802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Flag-Fbw7</a:t>
            </a:r>
            <a:endParaRPr lang="ko-KR" altLang="en-US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6197510" y="2508127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Flag-Fbw7</a:t>
            </a:r>
            <a:endParaRPr lang="ko-KR" altLang="en-US" sz="1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6197510" y="2905032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b="1" dirty="0" smtClean="0">
                <a:latin typeface="맑은 고딕"/>
                <a:ea typeface="맑은 고딕"/>
              </a:rPr>
              <a:t>β</a:t>
            </a:r>
            <a:r>
              <a:rPr lang="en-US" altLang="ko-KR" sz="1000" b="1" dirty="0" smtClean="0"/>
              <a:t>-actin</a:t>
            </a:r>
            <a:endParaRPr lang="ko-KR" altLang="en-US" sz="1000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3" t="4073"/>
          <a:stretch/>
        </p:blipFill>
        <p:spPr bwMode="auto">
          <a:xfrm>
            <a:off x="2398258" y="1558086"/>
            <a:ext cx="3739368" cy="380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8364" y="981508"/>
            <a:ext cx="3734246" cy="4537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8257" y="2842015"/>
            <a:ext cx="3725865" cy="372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5" name="그림 10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9672" y="3452621"/>
            <a:ext cx="4888380" cy="2690913"/>
          </a:xfrm>
          <a:prstGeom prst="rect">
            <a:avLst/>
          </a:prstGeom>
        </p:spPr>
      </p:pic>
      <p:pic>
        <p:nvPicPr>
          <p:cNvPr id="35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8257" y="2075241"/>
            <a:ext cx="3733786" cy="373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6183128" y="2142731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/>
              <a:t>XBP1</a:t>
            </a:r>
            <a:endParaRPr lang="ko-KR" altLang="en-US" sz="1000" b="1" dirty="0"/>
          </a:p>
        </p:txBody>
      </p:sp>
      <p:pic>
        <p:nvPicPr>
          <p:cNvPr id="37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7902" y="2479327"/>
            <a:ext cx="3733786" cy="3499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107504" y="6367901"/>
            <a:ext cx="73414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1. S212A site of Xbp1 is potential binding site for Fbw7  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30598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4</TotalTime>
  <Words>42</Words>
  <Application>Microsoft Office PowerPoint</Application>
  <PresentationFormat>화면 슬라이드 쇼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경률</dc:creator>
  <cp:lastModifiedBy>CUB</cp:lastModifiedBy>
  <cp:revision>13</cp:revision>
  <dcterms:created xsi:type="dcterms:W3CDTF">2015-07-23T07:48:08Z</dcterms:created>
  <dcterms:modified xsi:type="dcterms:W3CDTF">2018-09-22T06:12:43Z</dcterms:modified>
</cp:coreProperties>
</file>